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87" r:id="rId2"/>
  </p:sldIdLst>
  <p:sldSz cx="9144000" cy="6858000" type="screen4x3"/>
  <p:notesSz cx="6881813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996" autoAdjust="0"/>
    <p:restoredTop sz="88471" autoAdjust="0"/>
  </p:normalViewPr>
  <p:slideViewPr>
    <p:cSldViewPr snapToGrid="0">
      <p:cViewPr varScale="1">
        <p:scale>
          <a:sx n="97" d="100"/>
          <a:sy n="97" d="100"/>
        </p:scale>
        <p:origin x="123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5/10/relationships/revisionInfo" Target="revisionInfo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913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97313" y="0"/>
            <a:ext cx="2982912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EED73D-736B-43AC-AF16-95F5FE026706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2982913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97313" y="8829675"/>
            <a:ext cx="2982912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2C82BAA-9237-40AB-BD5F-D0DFCE56CB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89633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119" cy="466434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8102" y="0"/>
            <a:ext cx="2982119" cy="466434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r">
              <a:defRPr sz="1200"/>
            </a:lvl1pPr>
          </a:lstStyle>
          <a:p>
            <a:fld id="{79AF69ED-F154-485A-86A5-50488DFE62B7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50963" y="1162050"/>
            <a:ext cx="4179887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46" tIns="46223" rIns="92446" bIns="4622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182" y="4473892"/>
            <a:ext cx="5505450" cy="3660458"/>
          </a:xfrm>
          <a:prstGeom prst="rect">
            <a:avLst/>
          </a:prstGeom>
        </p:spPr>
        <p:txBody>
          <a:bodyPr vert="horz" lIns="92446" tIns="46223" rIns="92446" bIns="46223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82119" cy="46643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8102" y="8829967"/>
            <a:ext cx="2982119" cy="46643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r">
              <a:defRPr sz="1200"/>
            </a:lvl1pPr>
          </a:lstStyle>
          <a:p>
            <a:fld id="{C095A2F6-EE68-43C4-8F94-F29FE95816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6233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4801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5495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740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4270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62969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6605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28792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78211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6988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690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3070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373BFF-4E51-421F-BC7C-3C7669A37328}" type="datetimeFigureOut">
              <a:rPr lang="en-US" smtClean="0"/>
              <a:t>1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E09828-A1B9-4EC2-A740-383B8076C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803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Straight Connector 1"/>
          <p:cNvCxnSpPr/>
          <p:nvPr/>
        </p:nvCxnSpPr>
        <p:spPr>
          <a:xfrm>
            <a:off x="631642" y="2447374"/>
            <a:ext cx="3037971" cy="149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/>
          <p:cNvCxnSpPr/>
          <p:nvPr/>
        </p:nvCxnSpPr>
        <p:spPr>
          <a:xfrm>
            <a:off x="1026541" y="3151145"/>
            <a:ext cx="395364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/>
          <p:cNvCxnSpPr/>
          <p:nvPr/>
        </p:nvCxnSpPr>
        <p:spPr>
          <a:xfrm>
            <a:off x="2229071" y="3951975"/>
            <a:ext cx="325267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3780076" y="2218031"/>
            <a:ext cx="2962349" cy="46166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MD7 </a:t>
            </a:r>
            <a:r>
              <a:rPr lang="en-U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plicon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510 </a:t>
            </a:r>
            <a:r>
              <a:rPr lang="en-U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8 crRNAs</a:t>
            </a:r>
          </a:p>
          <a:p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 target: </a:t>
            </a:r>
            <a:r>
              <a:rPr lang="en-US" sz="1000" u="sng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GTGGAAGAAGTCCATGAT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TA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087841" y="2914800"/>
            <a:ext cx="2933495" cy="76944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MX1 </a:t>
            </a:r>
            <a:r>
              <a:rPr lang="en-U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plicon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635 </a:t>
            </a:r>
            <a:r>
              <a:rPr lang="en-U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13 crRNAs</a:t>
            </a:r>
          </a:p>
          <a:p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 target: </a:t>
            </a:r>
            <a:r>
              <a:rPr lang="en-US" sz="1000" u="sng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TGGTGCCTGGAAAATAAA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TAA</a:t>
            </a:r>
          </a:p>
          <a:p>
            <a:endParaRPr lang="en-US" sz="1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582681" y="3693910"/>
            <a:ext cx="2936701" cy="61555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CP </a:t>
            </a:r>
            <a:r>
              <a:rPr lang="en-U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plicon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567 </a:t>
            </a:r>
            <a:r>
              <a:rPr lang="en-U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5 crRNAs</a:t>
            </a:r>
          </a:p>
          <a:p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 target: </a:t>
            </a:r>
            <a:r>
              <a:rPr lang="en-US" sz="1000" u="sng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TACCCGGAAGTCATCCATA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TAA</a:t>
            </a:r>
          </a:p>
          <a:p>
            <a:endParaRPr lang="en-US" sz="1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Straight Connector 7"/>
          <p:cNvCxnSpPr/>
          <p:nvPr/>
        </p:nvCxnSpPr>
        <p:spPr>
          <a:xfrm>
            <a:off x="1453313" y="2305133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2846488" y="2293485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>
            <a:off x="936203" y="2293485"/>
            <a:ext cx="435935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585580" y="1796365"/>
            <a:ext cx="882251" cy="369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rt 200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from ends</a:t>
            </a:r>
          </a:p>
        </p:txBody>
      </p:sp>
      <p:cxnSp>
        <p:nvCxnSpPr>
          <p:cNvPr id="12" name="Straight Connector 11"/>
          <p:cNvCxnSpPr/>
          <p:nvPr/>
        </p:nvCxnSpPr>
        <p:spPr>
          <a:xfrm rot="5400000">
            <a:off x="1620960" y="2369407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rot="5400000">
            <a:off x="1773360" y="2415477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 rot="5400000">
            <a:off x="1925760" y="2450914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 rot="5400000">
            <a:off x="2078160" y="2496984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rot="5400000">
            <a:off x="2230560" y="2543054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rot="5400000">
            <a:off x="2382960" y="2578491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 rot="5400000">
            <a:off x="2006226" y="3004348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 rot="5400000">
            <a:off x="2528265" y="2628099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rot="5400000">
            <a:off x="2623401" y="2674203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535841" y="1038629"/>
            <a:ext cx="742191" cy="3077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2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3 Fig</a:t>
            </a:r>
          </a:p>
        </p:txBody>
      </p:sp>
      <p:cxnSp>
        <p:nvCxnSpPr>
          <p:cNvPr id="22" name="Straight Connector 21"/>
          <p:cNvCxnSpPr/>
          <p:nvPr/>
        </p:nvCxnSpPr>
        <p:spPr>
          <a:xfrm>
            <a:off x="2358942" y="2986882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3752117" y="2975234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3120188" y="3798086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4513363" y="3786438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rot="5400000">
            <a:off x="2538337" y="3073279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rot="5400000">
            <a:off x="2690737" y="3119349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 rot="5400000">
            <a:off x="2843137" y="3154786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 rot="5400000">
            <a:off x="2995537" y="3200856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 rot="5400000">
            <a:off x="3147937" y="3246926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rot="5400000">
            <a:off x="3300337" y="3282363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 rot="5400000">
            <a:off x="3445642" y="3331971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rot="5400000">
            <a:off x="3540778" y="3378075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 rot="5400000">
            <a:off x="3288426" y="3874109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 rot="5400000">
            <a:off x="3440826" y="3920179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 rot="5400000">
            <a:off x="3593226" y="3955616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 rot="5400000">
            <a:off x="3745626" y="4001686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 rot="5400000">
            <a:off x="3898026" y="4047756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 rot="5400000">
            <a:off x="4050426" y="4083193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rot="5400000">
            <a:off x="4195731" y="4132801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 rot="5400000">
            <a:off x="4290867" y="3983833"/>
            <a:ext cx="0" cy="3077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359432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27</TotalTime>
  <Words>44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erson, Emily (GE Healthcare)</dc:creator>
  <cp:lastModifiedBy>Emily Anderson</cp:lastModifiedBy>
  <cp:revision>37</cp:revision>
  <cp:lastPrinted>2017-08-23T20:39:11Z</cp:lastPrinted>
  <dcterms:created xsi:type="dcterms:W3CDTF">2017-06-20T17:09:07Z</dcterms:created>
  <dcterms:modified xsi:type="dcterms:W3CDTF">2018-01-16T17:58:05Z</dcterms:modified>
</cp:coreProperties>
</file>